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A336F-A014-4316-9A9C-A88634A4A9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50B55-2488-47DE-BDF3-9EDFECBE67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E1EDB-9692-4121-88F7-4392669D9A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1E4F3-52D0-4383-BAD2-DC997B8E3D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FE4F8-E208-4DAA-B687-1573CA996F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339DD-FB4F-4402-8B3C-59FDB0AB00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5491D-A954-4416-9E11-18332B5FBC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65231-9675-4C4F-A58A-0F25C96241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ED131-8693-4CD3-972D-697DF5B68E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2644E-C284-488E-B807-36E48C88BC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29788-BB85-4ABC-98DC-6AA404BD98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2E037-9BE8-423E-A45B-CE01E0B761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373B6B-8099-4344-B063-C61A15B469F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8.png"/><Relationship Id="rId7" Type="http://schemas.openxmlformats.org/officeDocument/2006/relationships/image" Target="../media/image9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49600" y="1109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80480" y="585720"/>
            <a:ext cx="213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</a:rPr>
              <a:t>Supplementary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620640" y="1361520"/>
            <a:ext cx="2623680" cy="2489760"/>
            <a:chOff x="620640" y="1361520"/>
            <a:chExt cx="2623680" cy="2489760"/>
          </a:xfrm>
        </p:grpSpPr>
        <p:sp>
          <p:nvSpPr>
            <p:cNvPr id="44" name=""/>
            <p:cNvSpPr/>
            <p:nvPr/>
          </p:nvSpPr>
          <p:spPr>
            <a:xfrm>
              <a:off x="766080" y="314388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1197000" y="1361520"/>
              <a:ext cx="2047320" cy="2489760"/>
              <a:chOff x="1197000" y="1361520"/>
              <a:chExt cx="2047320" cy="2489760"/>
            </a:xfrm>
          </p:grpSpPr>
          <p:grpSp>
            <p:nvGrpSpPr>
              <p:cNvPr id="46" name=""/>
              <p:cNvGrpSpPr/>
              <p:nvPr/>
            </p:nvGrpSpPr>
            <p:grpSpPr>
              <a:xfrm>
                <a:off x="1197000" y="2087640"/>
                <a:ext cx="1728720" cy="1763640"/>
                <a:chOff x="1197000" y="2087640"/>
                <a:chExt cx="1728720" cy="1763640"/>
              </a:xfrm>
            </p:grpSpPr>
            <p:pic>
              <p:nvPicPr>
                <p:cNvPr id="47" name="" descr=""/>
                <p:cNvPicPr/>
                <p:nvPr/>
              </p:nvPicPr>
              <p:blipFill>
                <a:blip r:embed="rId1"/>
                <a:srcRect l="5925" t="9193" r="73897" b="29173"/>
                <a:stretch/>
              </p:blipFill>
              <p:spPr>
                <a:xfrm>
                  <a:off x="1197000" y="2087640"/>
                  <a:ext cx="576360" cy="1763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8" name="" descr=""/>
                <p:cNvPicPr/>
                <p:nvPr/>
              </p:nvPicPr>
              <p:blipFill>
                <a:blip r:embed="rId2"/>
                <a:srcRect l="46252" t="9193" r="13373" b="29173"/>
                <a:stretch/>
              </p:blipFill>
              <p:spPr>
                <a:xfrm>
                  <a:off x="1773360" y="2087640"/>
                  <a:ext cx="1152360" cy="17636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49" name=""/>
              <p:cNvSpPr/>
              <p:nvPr/>
            </p:nvSpPr>
            <p:spPr>
              <a:xfrm rot="18537600">
                <a:off x="1347840" y="1647720"/>
                <a:ext cx="863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rot="18372600">
                <a:off x="1650240" y="1662120"/>
                <a:ext cx="808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EMA3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rot="18232200">
                <a:off x="1938600" y="1657440"/>
                <a:ext cx="808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EMA3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rot="18271200">
                <a:off x="2229840" y="1661040"/>
                <a:ext cx="801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EMA3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rot="18003600">
                <a:off x="2510640" y="1646280"/>
                <a:ext cx="81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EMA3G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765000" y="2916000"/>
              <a:ext cx="57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 -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66080" y="264168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.0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20640" y="342576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87-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73200" y="192888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K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3429000" y="1417320"/>
            <a:ext cx="2867760" cy="1764000"/>
            <a:chOff x="3429000" y="1417320"/>
            <a:chExt cx="2867760" cy="1764000"/>
          </a:xfrm>
        </p:grpSpPr>
        <p:sp>
          <p:nvSpPr>
            <p:cNvPr id="59" name=""/>
            <p:cNvSpPr/>
            <p:nvPr/>
          </p:nvSpPr>
          <p:spPr>
            <a:xfrm rot="18733800">
              <a:off x="4477680" y="167256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EMA3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8760200">
              <a:off x="5039280" y="1674000"/>
              <a:ext cx="80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EMA3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501360" y="264708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501360" y="241776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.0 -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429000" y="198612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Kb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" descr=""/>
            <p:cNvPicPr/>
            <p:nvPr/>
          </p:nvPicPr>
          <p:blipFill>
            <a:blip r:embed="rId3"/>
            <a:srcRect l="9237" t="34988" r="39098" b="9688"/>
            <a:stretch/>
          </p:blipFill>
          <p:spPr>
            <a:xfrm>
              <a:off x="3933720" y="2102040"/>
              <a:ext cx="201636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"/>
            <p:cNvSpPr/>
            <p:nvPr/>
          </p:nvSpPr>
          <p:spPr>
            <a:xfrm rot="18753600">
              <a:off x="5517000" y="1670040"/>
              <a:ext cx="808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EMA4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441720" y="112680"/>
            <a:ext cx="203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D/2008/3038 revised version</a:t>
            </a: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"/>
          <p:cNvGrpSpPr/>
          <p:nvPr/>
        </p:nvGrpSpPr>
        <p:grpSpPr>
          <a:xfrm>
            <a:off x="693720" y="6227640"/>
            <a:ext cx="2735280" cy="1514520"/>
            <a:chOff x="693720" y="6227640"/>
            <a:chExt cx="2735280" cy="1514520"/>
          </a:xfrm>
        </p:grpSpPr>
        <p:pic>
          <p:nvPicPr>
            <p:cNvPr id="68" name="" descr=""/>
            <p:cNvPicPr/>
            <p:nvPr/>
          </p:nvPicPr>
          <p:blipFill>
            <a:blip r:embed="rId1"/>
            <a:srcRect l="2063" t="14011" r="18466" b="26865"/>
            <a:stretch/>
          </p:blipFill>
          <p:spPr>
            <a:xfrm>
              <a:off x="693720" y="6227640"/>
              <a:ext cx="2735280" cy="151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867240" y="6483240"/>
              <a:ext cx="111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3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>
            <a:off x="489240" y="604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3789360" y="1403280"/>
            <a:ext cx="2736720" cy="4782960"/>
            <a:chOff x="3789360" y="1403280"/>
            <a:chExt cx="2736720" cy="4782960"/>
          </a:xfrm>
        </p:grpSpPr>
        <p:pic>
          <p:nvPicPr>
            <p:cNvPr id="72" name="" descr=""/>
            <p:cNvPicPr/>
            <p:nvPr/>
          </p:nvPicPr>
          <p:blipFill>
            <a:blip r:embed="rId2"/>
            <a:srcRect l="2063" t="14011" r="18466" b="26865"/>
            <a:stretch/>
          </p:blipFill>
          <p:spPr>
            <a:xfrm>
              <a:off x="3789360" y="1403280"/>
              <a:ext cx="2707920" cy="15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"/>
            <p:cNvSpPr/>
            <p:nvPr/>
          </p:nvSpPr>
          <p:spPr>
            <a:xfrm>
              <a:off x="3976560" y="1566720"/>
              <a:ext cx="110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3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4" name="" descr=""/>
            <p:cNvPicPr/>
            <p:nvPr/>
          </p:nvPicPr>
          <p:blipFill>
            <a:blip r:embed="rId3"/>
            <a:srcRect l="2063" t="14011" r="18466" b="26865"/>
            <a:stretch/>
          </p:blipFill>
          <p:spPr>
            <a:xfrm>
              <a:off x="3789360" y="3019320"/>
              <a:ext cx="2736720" cy="151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"/>
            <p:cNvSpPr/>
            <p:nvPr/>
          </p:nvSpPr>
          <p:spPr>
            <a:xfrm>
              <a:off x="3951000" y="3222360"/>
              <a:ext cx="113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3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6" name="" descr=""/>
            <p:cNvPicPr/>
            <p:nvPr/>
          </p:nvPicPr>
          <p:blipFill>
            <a:blip r:embed="rId4"/>
            <a:srcRect l="2063" t="14011" r="18466" b="26865"/>
            <a:stretch/>
          </p:blipFill>
          <p:spPr>
            <a:xfrm>
              <a:off x="3789360" y="4682880"/>
              <a:ext cx="2736720" cy="150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"/>
            <p:cNvSpPr/>
            <p:nvPr/>
          </p:nvSpPr>
          <p:spPr>
            <a:xfrm>
              <a:off x="3963960" y="4951080"/>
              <a:ext cx="111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4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692280" y="1432080"/>
            <a:ext cx="2736720" cy="4724280"/>
            <a:chOff x="692280" y="1432080"/>
            <a:chExt cx="2736720" cy="4724280"/>
          </a:xfrm>
        </p:grpSpPr>
        <p:pic>
          <p:nvPicPr>
            <p:cNvPr id="79" name="" descr=""/>
            <p:cNvPicPr/>
            <p:nvPr/>
          </p:nvPicPr>
          <p:blipFill>
            <a:blip r:embed="rId5"/>
            <a:srcRect l="0" t="14232" r="18466" b="26580"/>
            <a:stretch/>
          </p:blipFill>
          <p:spPr>
            <a:xfrm>
              <a:off x="692280" y="3016080"/>
              <a:ext cx="2736720" cy="1516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"/>
            <p:cNvSpPr/>
            <p:nvPr/>
          </p:nvSpPr>
          <p:spPr>
            <a:xfrm>
              <a:off x="909720" y="3159000"/>
              <a:ext cx="110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3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1" name="" descr=""/>
            <p:cNvPicPr/>
            <p:nvPr/>
          </p:nvPicPr>
          <p:blipFill>
            <a:blip r:embed="rId6"/>
            <a:srcRect l="2063" t="14031" r="18466" b="25064"/>
            <a:stretch/>
          </p:blipFill>
          <p:spPr>
            <a:xfrm>
              <a:off x="692280" y="4672080"/>
              <a:ext cx="2734920" cy="1484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"/>
            <p:cNvSpPr/>
            <p:nvPr/>
          </p:nvSpPr>
          <p:spPr>
            <a:xfrm>
              <a:off x="909720" y="4815000"/>
              <a:ext cx="1119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MA3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" name=""/>
            <p:cNvGrpSpPr/>
            <p:nvPr/>
          </p:nvGrpSpPr>
          <p:grpSpPr>
            <a:xfrm>
              <a:off x="692280" y="1432080"/>
              <a:ext cx="2665080" cy="1476360"/>
              <a:chOff x="692280" y="1432080"/>
              <a:chExt cx="2665080" cy="1476360"/>
            </a:xfrm>
          </p:grpSpPr>
          <p:pic>
            <p:nvPicPr>
              <p:cNvPr id="84" name="" descr=""/>
              <p:cNvPicPr/>
              <p:nvPr/>
            </p:nvPicPr>
            <p:blipFill>
              <a:blip r:embed="rId7"/>
              <a:srcRect l="3695" t="16538" r="18997" b="26367"/>
              <a:stretch/>
            </p:blipFill>
            <p:spPr>
              <a:xfrm>
                <a:off x="692280" y="1432080"/>
                <a:ext cx="2665080" cy="1476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5" name=""/>
              <p:cNvSpPr/>
              <p:nvPr/>
            </p:nvSpPr>
            <p:spPr>
              <a:xfrm>
                <a:off x="809640" y="1521000"/>
                <a:ext cx="1107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SEMA3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2T07:05:22Z</dcterms:created>
  <dc:creator>J. ROCHE</dc:creator>
  <dc:description/>
  <dc:language>en-US</dc:language>
  <cp:lastModifiedBy>DFCI</cp:lastModifiedBy>
  <dcterms:modified xsi:type="dcterms:W3CDTF">2008-05-20T15:06:26Z</dcterms:modified>
  <cp:revision>10</cp:revision>
  <dc:subject/>
  <dc:title>Diapositive 1</dc:title>
</cp:coreProperties>
</file>